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25"/>
  </p:normalViewPr>
  <p:slideViewPr>
    <p:cSldViewPr snapToGrid="0">
      <p:cViewPr varScale="1">
        <p:scale>
          <a:sx n="128" d="100"/>
          <a:sy n="128" d="100"/>
        </p:scale>
        <p:origin x="176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91F6CE-FA44-FF3C-8AA9-9E40A21F65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22FB4CE-18DF-8BE3-B2CF-95C98A7E9A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F0AB55-0E29-6F5A-24BA-8D80287911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9EF1-B67E-F045-AF34-F49A068AD06E}" type="datetimeFigureOut">
              <a:rPr lang="en-US" smtClean="0"/>
              <a:t>2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BCF3CF-D8BE-AE0D-25C7-F8FA91D191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D4F183-122F-B489-349D-43F0AB2182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B7A86-9013-3743-A1A6-60E462F4CF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1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B9348F-4DA4-E3A3-2E33-84E082FF32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2FA108-538D-7B1F-53EB-ECC7C77968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C3BB34-899A-5072-50A1-E70EA062F0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9EF1-B67E-F045-AF34-F49A068AD06E}" type="datetimeFigureOut">
              <a:rPr lang="en-US" smtClean="0"/>
              <a:t>2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552A83-E9EA-7A19-8098-6FD72B60DD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1FCEFF-8305-776C-4171-83815DED6B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B7A86-9013-3743-A1A6-60E462F4CF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364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742D70-3C53-2E99-9936-976163334E8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5BE8BE-604C-67BE-9A38-AB2070F99F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555808-B57D-6244-D0A8-EE151C181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9EF1-B67E-F045-AF34-F49A068AD06E}" type="datetimeFigureOut">
              <a:rPr lang="en-US" smtClean="0"/>
              <a:t>2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05369C-F82D-BC32-2326-94231B170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702A56-3738-660F-49B8-FE4A5FC9FD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B7A86-9013-3743-A1A6-60E462F4CF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848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B46E95-2399-A4CB-AE2D-348BD21F1A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44494E-B605-EBB5-8FEA-7C63A6EF63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ABAD36-53F6-12E6-E831-CA6FDDA7F5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9EF1-B67E-F045-AF34-F49A068AD06E}" type="datetimeFigureOut">
              <a:rPr lang="en-US" smtClean="0"/>
              <a:t>2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2037E1-41AC-9E54-1B1D-AD775651CF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D497D6-064F-B144-E117-5CFF4EEB9D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B7A86-9013-3743-A1A6-60E462F4CF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9530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BE19F7-DAB1-66B8-BAC3-D47F6B44B9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212F9B-E7A2-326B-F85D-57C9DB4316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0B7588-D8C8-151A-8D1E-84DCB60E1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9EF1-B67E-F045-AF34-F49A068AD06E}" type="datetimeFigureOut">
              <a:rPr lang="en-US" smtClean="0"/>
              <a:t>2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1C6B04-DB90-5C58-4CDE-F5ECEDE39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EDAC6F-5B0F-40A6-9E10-56CC1999A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B7A86-9013-3743-A1A6-60E462F4CF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166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D8D5B6-F272-33EB-79BE-EE84D0B3EE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E561AF-C774-CDAC-00AA-34634C71E65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460FD6-6D55-7966-3B6F-356FD4F52F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1B816D-8463-11B9-7A9E-48BE664750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9EF1-B67E-F045-AF34-F49A068AD06E}" type="datetimeFigureOut">
              <a:rPr lang="en-US" smtClean="0"/>
              <a:t>2/1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904CD2-9C9D-CCB9-CBC4-5E5665935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5E65F8-6644-E175-F360-3CED99DECD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B7A86-9013-3743-A1A6-60E462F4CF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583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C4094F-C439-CBBB-BB6A-D46FD5826C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D1BD6D-DBFC-05AC-9C71-285A0B9CD1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9F99EA-25C1-932C-E7BB-E93C3A059F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C9F3C4C-D3B7-444A-354C-D2F88C245C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D3B0643-1AE8-90A6-7932-D4707620A9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FAF0AC2-EFF0-8DAC-2556-8F39942C86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9EF1-B67E-F045-AF34-F49A068AD06E}" type="datetimeFigureOut">
              <a:rPr lang="en-US" smtClean="0"/>
              <a:t>2/19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6EB99E1-35A0-1A9D-A2E9-498C1B772C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64E6AAB-1934-36BB-E016-4E0A48053D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B7A86-9013-3743-A1A6-60E462F4CF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1501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E0972B-02E7-24AA-5B80-3240F840DC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045427-C035-31A0-269D-E926DA2AE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9EF1-B67E-F045-AF34-F49A068AD06E}" type="datetimeFigureOut">
              <a:rPr lang="en-US" smtClean="0"/>
              <a:t>2/19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5778ADC-C0D3-95D6-2A22-D186AE4F23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D85E010-D2F5-571A-6F38-FD0F11AF9E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B7A86-9013-3743-A1A6-60E462F4CF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2637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75BA9C0-46C5-FABA-0F41-EAD38877DF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9EF1-B67E-F045-AF34-F49A068AD06E}" type="datetimeFigureOut">
              <a:rPr lang="en-US" smtClean="0"/>
              <a:t>2/19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6D9A1DD-A7CD-1304-3C4F-A54977083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52D463B-CECD-F16E-5F8F-112AC4B42D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B7A86-9013-3743-A1A6-60E462F4CF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7137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82CCEA-C390-5B9C-D887-3BCB7B1C08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323FF6-848E-7F6B-C3B2-F43BE987E5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467B939-BCF4-5C57-7B33-EB5EF32CC0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7838D3-8EBF-3E98-E638-3E93FEDC35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9EF1-B67E-F045-AF34-F49A068AD06E}" type="datetimeFigureOut">
              <a:rPr lang="en-US" smtClean="0"/>
              <a:t>2/1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F3630B-2C8E-495C-7391-5F825BFD1B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AACC5A-653E-7AD2-7F40-B8DD6BCD5E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B7A86-9013-3743-A1A6-60E462F4CF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181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BA32ED-6DB6-B2AE-E155-80796A81B8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2E5D1CC-D019-AA37-9F56-DDF4B6FAC7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CDBAABC-9E1D-7EC8-90DC-DCC683A480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61DA9C-2FC1-52A9-2E38-1BDBA21B62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A89EF1-B67E-F045-AF34-F49A068AD06E}" type="datetimeFigureOut">
              <a:rPr lang="en-US" smtClean="0"/>
              <a:t>2/1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DF5A0C-A2BC-0B84-0C6F-B390F8DE39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F40EDE-EE3E-3B67-87C0-087835EFF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B7A86-9013-3743-A1A6-60E462F4CF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593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9F9E763-8488-4609-3404-F7E69CB711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63EA6A-6D66-0D4C-68D4-695E192F44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EEB668-F42A-EBB2-5C4B-D276F03E88C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EA89EF1-B67E-F045-AF34-F49A068AD06E}" type="datetimeFigureOut">
              <a:rPr lang="en-US" smtClean="0"/>
              <a:t>2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F3E326-A34C-4DB0-8037-8A770B893D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A63BFA-2470-5612-9AC6-0624B2BF631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B0B7A86-9013-3743-A1A6-60E462F4CF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6804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diagram of a training set&#10;&#10;Description automatically generated">
            <a:extLst>
              <a:ext uri="{FF2B5EF4-FFF2-40B4-BE49-F238E27FC236}">
                <a16:creationId xmlns:a16="http://schemas.microsoft.com/office/drawing/2014/main" id="{7C1A0099-1E5C-DC83-8C27-DCCD72C7FB8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1153" y="497839"/>
            <a:ext cx="7527907" cy="414034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2A44570-7021-630E-51CC-FFD1A366BF4B}"/>
              </a:ext>
            </a:extLst>
          </p:cNvPr>
          <p:cNvSpPr txBox="1"/>
          <p:nvPr/>
        </p:nvSpPr>
        <p:spPr>
          <a:xfrm>
            <a:off x="786809" y="5116653"/>
            <a:ext cx="10154093" cy="5669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Aft>
                <a:spcPts val="80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ry Figure S4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sz="18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Illustration of the </a:t>
            </a:r>
            <a:r>
              <a:rPr lang="en-US" sz="1800" dirty="0" err="1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SignaL</a:t>
            </a:r>
            <a:r>
              <a:rPr lang="en-US" sz="18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features extraction and selection procedure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55729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9</TotalTime>
  <Words>14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mel Lahouel</dc:creator>
  <cp:lastModifiedBy>Kamel Lahouel</cp:lastModifiedBy>
  <cp:revision>1</cp:revision>
  <dcterms:created xsi:type="dcterms:W3CDTF">2025-02-19T23:02:42Z</dcterms:created>
  <dcterms:modified xsi:type="dcterms:W3CDTF">2025-02-20T04:52:11Z</dcterms:modified>
</cp:coreProperties>
</file>